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LESSANDRA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483" autoAdjust="0"/>
  </p:normalViewPr>
  <p:slideViewPr>
    <p:cSldViewPr snapToGrid="0" snapToObjects="1">
      <p:cViewPr>
        <p:scale>
          <a:sx n="100" d="100"/>
          <a:sy n="100" d="100"/>
        </p:scale>
        <p:origin x="-70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660BED-C85B-3144-931A-9A88B0A2388A}" type="datetimeFigureOut">
              <a:rPr lang="en-US" smtClean="0"/>
              <a:t>4/6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EB5662-4165-1F40-A49B-BC02C6FAFD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8511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E6E41-0C2C-5644-BEF8-6F625B03C52A}" type="datetimeFigureOut">
              <a:rPr lang="en-US" smtClean="0"/>
              <a:t>4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B463C-58E2-C34D-A256-DD25EEE2D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08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E6E41-0C2C-5644-BEF8-6F625B03C52A}" type="datetimeFigureOut">
              <a:rPr lang="en-US" smtClean="0"/>
              <a:t>4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B463C-58E2-C34D-A256-DD25EEE2D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117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E6E41-0C2C-5644-BEF8-6F625B03C52A}" type="datetimeFigureOut">
              <a:rPr lang="en-US" smtClean="0"/>
              <a:t>4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B463C-58E2-C34D-A256-DD25EEE2D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89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E6E41-0C2C-5644-BEF8-6F625B03C52A}" type="datetimeFigureOut">
              <a:rPr lang="en-US" smtClean="0"/>
              <a:t>4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B463C-58E2-C34D-A256-DD25EEE2D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365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E6E41-0C2C-5644-BEF8-6F625B03C52A}" type="datetimeFigureOut">
              <a:rPr lang="en-US" smtClean="0"/>
              <a:t>4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B463C-58E2-C34D-A256-DD25EEE2D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118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E6E41-0C2C-5644-BEF8-6F625B03C52A}" type="datetimeFigureOut">
              <a:rPr lang="en-US" smtClean="0"/>
              <a:t>4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B463C-58E2-C34D-A256-DD25EEE2D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822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E6E41-0C2C-5644-BEF8-6F625B03C52A}" type="datetimeFigureOut">
              <a:rPr lang="en-US" smtClean="0"/>
              <a:t>4/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B463C-58E2-C34D-A256-DD25EEE2D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557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E6E41-0C2C-5644-BEF8-6F625B03C52A}" type="datetimeFigureOut">
              <a:rPr lang="en-US" smtClean="0"/>
              <a:t>4/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B463C-58E2-C34D-A256-DD25EEE2D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111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E6E41-0C2C-5644-BEF8-6F625B03C52A}" type="datetimeFigureOut">
              <a:rPr lang="en-US" smtClean="0"/>
              <a:t>4/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B463C-58E2-C34D-A256-DD25EEE2D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14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E6E41-0C2C-5644-BEF8-6F625B03C52A}" type="datetimeFigureOut">
              <a:rPr lang="en-US" smtClean="0"/>
              <a:t>4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B463C-58E2-C34D-A256-DD25EEE2D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94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7E6E41-0C2C-5644-BEF8-6F625B03C52A}" type="datetimeFigureOut">
              <a:rPr lang="en-US" smtClean="0"/>
              <a:t>4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B463C-58E2-C34D-A256-DD25EEE2D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161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E6E41-0C2C-5644-BEF8-6F625B03C52A}" type="datetimeFigureOut">
              <a:rPr lang="en-US" smtClean="0"/>
              <a:t>4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B463C-58E2-C34D-A256-DD25EEE2D3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020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/>
          <p:cNvSpPr txBox="1"/>
          <p:nvPr/>
        </p:nvSpPr>
        <p:spPr>
          <a:xfrm>
            <a:off x="8337583" y="87868"/>
            <a:ext cx="604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/>
              <a:t>SM1</a:t>
            </a:r>
            <a:endParaRPr lang="en-IE" dirty="0"/>
          </a:p>
        </p:txBody>
      </p:sp>
      <p:pic>
        <p:nvPicPr>
          <p:cNvPr id="49" name="Picture 4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504" y="4293097"/>
            <a:ext cx="4824536" cy="2362412"/>
          </a:xfrm>
          <a:prstGeom prst="rect">
            <a:avLst/>
          </a:prstGeom>
        </p:spPr>
      </p:pic>
      <p:sp>
        <p:nvSpPr>
          <p:cNvPr id="51" name="TextBox 50"/>
          <p:cNvSpPr txBox="1"/>
          <p:nvPr/>
        </p:nvSpPr>
        <p:spPr>
          <a:xfrm>
            <a:off x="72000" y="548680"/>
            <a:ext cx="2744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/>
              <a:t>A</a:t>
            </a:r>
            <a:endParaRPr lang="en-US" sz="1100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504" y="548680"/>
            <a:ext cx="4983336" cy="3246336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5353049" y="457200"/>
            <a:ext cx="3589187" cy="65556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1.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hTeg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lycoprotein subsets are efficiently isolated by hydrazide 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tinylation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ffinity chromatography.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ligosaccharides on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hTe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lycoproteins were selectively labelled with EZ-link Hydrazide-Biotin, according to manufacturer guidelines and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tinylatio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ducts, resulting in the fraction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hTe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B, which was subsequently applied to a monomeric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idi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garose column. Non-biotinylated (non-glycosylated) proteins flowed through the column constituting the FT fraction, while biotinylated (glycosylated) proteins were displaced from beads-immobilise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idi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elution with concentrated biotin in reducing conditions. Alternatively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CA or GNL were used to isolate glycoconjugates rich in mannose from unlabelle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hTe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hTe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incubated with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, LCA-, or GNL-agarose slurry in end-over-end agitation overnight at +4ºC. Unbound fractions were collected and, following extensive washing, columns were incubated for 3h at RT with inhibiting sugars and bound fractions were eluted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efficient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tinylatio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hTe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lycoproteins was verified by Lectin blot; starting material (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hTe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tinylatio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duct (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hTe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B) were probed with IR-labelled streptavidin complex. MW: molecular weight marker; equal amount of proteins were loaded in each lane (15ug)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Lectin blot of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idi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romatography elution fractions. Biotin-conjugated proteins (15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protein per lane) were probed with IR-800 Streptavidin. FT: flow through fraction; B: bound fraction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: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ctin chromatography efficiency was assessed by lectin blot probing the bound fractions with appropriate biotin-labelled lectins/IR-labelled streptavidin complex (green), MW marker (Red).</a:t>
            </a:r>
            <a:endParaRPr lang="en-I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84215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3</TotalTime>
  <Words>267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SSANDRA</dc:creator>
  <cp:lastModifiedBy>Dublin City University</cp:lastModifiedBy>
  <cp:revision>31</cp:revision>
  <dcterms:created xsi:type="dcterms:W3CDTF">2015-03-20T13:11:04Z</dcterms:created>
  <dcterms:modified xsi:type="dcterms:W3CDTF">2016-04-06T07:37:29Z</dcterms:modified>
</cp:coreProperties>
</file>